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A5A43"/>
    <a:srgbClr val="6A1171"/>
    <a:srgbClr val="548361"/>
    <a:srgbClr val="83278B"/>
    <a:srgbClr val="9FC1A9"/>
    <a:srgbClr val="C496C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88390" autoAdjust="0"/>
  </p:normalViewPr>
  <p:slideViewPr>
    <p:cSldViewPr snapToGrid="0">
      <p:cViewPr varScale="1">
        <p:scale>
          <a:sx n="91" d="100"/>
          <a:sy n="91" d="100"/>
        </p:scale>
        <p:origin x="285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3F5A7B-C95E-4A67-AB39-AEE3198755E0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76EA35-F916-43CF-9BF3-8581BDCCB2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1175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33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43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292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6259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3842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5404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98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670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8535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083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879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A1EC4-5990-422F-A37C-BD391176EA3D}" type="datetimeFigureOut">
              <a:rPr lang="en-US" smtClean="0"/>
              <a:t>3/30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50E7BB-74AA-4782-A03D-8E926DF6B48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563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ase video 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-1" r="-25"/>
          <a:stretch/>
        </p:blipFill>
        <p:spPr>
          <a:xfrm>
            <a:off x="1421245" y="0"/>
            <a:ext cx="10770755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" y="184640"/>
            <a:ext cx="14212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F1.</a:t>
            </a:r>
          </a:p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xial chest CT displaying pulmonary disease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74866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ase video 3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423987" y="0"/>
            <a:ext cx="10768013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" y="184640"/>
            <a:ext cx="14212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F2.</a:t>
            </a:r>
          </a:p>
          <a:p>
            <a:r>
              <a:rPr lang="en-US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ronal chest CT displaying pulmonary disease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9712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81</TotalTime>
  <Words>18</Words>
  <Application>Microsoft Office PowerPoint</Application>
  <PresentationFormat>Widescreen</PresentationFormat>
  <Paragraphs>4</Paragraphs>
  <Slides>2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UCLA Healt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sen, Beth K. MD</dc:creator>
  <cp:lastModifiedBy>Lee</cp:lastModifiedBy>
  <cp:revision>85</cp:revision>
  <dcterms:created xsi:type="dcterms:W3CDTF">2023-04-21T03:59:47Z</dcterms:created>
  <dcterms:modified xsi:type="dcterms:W3CDTF">2024-03-30T10:49:00Z</dcterms:modified>
</cp:coreProperties>
</file>